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859088" cy="2859088"/>
  <p:notesSz cx="6858000" cy="9144000"/>
  <p:defaultTextStyle>
    <a:defPPr>
      <a:defRPr lang="ja-JP"/>
    </a:defPPr>
    <a:lvl1pPr marL="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1pPr>
    <a:lvl2pPr marL="163358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2pPr>
    <a:lvl3pPr marL="326715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3pPr>
    <a:lvl4pPr marL="490073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4pPr>
    <a:lvl5pPr marL="65343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5pPr>
    <a:lvl6pPr marL="816788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6pPr>
    <a:lvl7pPr marL="980145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7pPr>
    <a:lvl8pPr marL="1143503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8pPr>
    <a:lvl9pPr marL="130686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01">
          <p15:clr>
            <a:srgbClr val="A4A3A4"/>
          </p15:clr>
        </p15:guide>
        <p15:guide id="2" pos="90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358" d="100"/>
          <a:sy n="358" d="100"/>
        </p:scale>
        <p:origin x="3906" y="270"/>
      </p:cViewPr>
      <p:guideLst>
        <p:guide orient="horz" pos="901"/>
        <p:guide pos="90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esktop\&#12467;&#12500;&#12540;&#26368;&#32066;&#12288;&#20877;&#21106;&#12426;&#20184;&#12369;&#24460;&#12288;Kudo%20triplet%20Xenograft%20model%20&#35251;&#23519;&#12501;&#12449;&#12452;&#12523;%20RPC-9%20Xeno%202016.12.10%20(1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esktop\&#12467;&#12500;&#12540;&#26368;&#32066;&#12288;&#20877;&#21106;&#12426;&#20184;&#12369;&#24460;&#12288;Kudo%20triplet%20Xenograft%20model%20&#35251;&#23519;&#12501;&#12449;&#12452;&#12523;%20RPC-9%20Xeno%202016.12.10%20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856264837376597"/>
          <c:y val="4.5318144664521914E-2"/>
          <c:w val="0.9005772231673318"/>
          <c:h val="0.8377697518907982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D$194</c:f>
              <c:strCache>
                <c:ptCount val="1"/>
                <c:pt idx="0">
                  <c:v>Osimertinib→Osimertinib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heet1!$E$133:$U$133</c:f>
                <c:numCache>
                  <c:formatCode>General</c:formatCode>
                  <c:ptCount val="17"/>
                  <c:pt idx="0">
                    <c:v>40.496479093458383</c:v>
                  </c:pt>
                  <c:pt idx="1">
                    <c:v>22.922011157266333</c:v>
                  </c:pt>
                  <c:pt idx="2">
                    <c:v>11.918377168626099</c:v>
                  </c:pt>
                  <c:pt idx="3">
                    <c:v>6.2951353338597809</c:v>
                  </c:pt>
                  <c:pt idx="4">
                    <c:v>14.355618676971099</c:v>
                  </c:pt>
                  <c:pt idx="5">
                    <c:v>7.3981275627022498</c:v>
                  </c:pt>
                  <c:pt idx="6">
                    <c:v>13.416752925580465</c:v>
                  </c:pt>
                  <c:pt idx="7">
                    <c:v>14.511128346591946</c:v>
                  </c:pt>
                  <c:pt idx="8">
                    <c:v>17.554013522422458</c:v>
                  </c:pt>
                  <c:pt idx="9">
                    <c:v>32.023977631001209</c:v>
                  </c:pt>
                  <c:pt idx="10">
                    <c:v>50.139567591475895</c:v>
                  </c:pt>
                  <c:pt idx="11">
                    <c:v>71.405722389835091</c:v>
                  </c:pt>
                  <c:pt idx="12">
                    <c:v>77.91151339891799</c:v>
                  </c:pt>
                  <c:pt idx="13">
                    <c:v>102.50046764236862</c:v>
                  </c:pt>
                  <c:pt idx="14">
                    <c:v>116.35598394728521</c:v>
                  </c:pt>
                  <c:pt idx="15">
                    <c:v>141.84032637128971</c:v>
                  </c:pt>
                  <c:pt idx="16">
                    <c:v>158.47544677731801</c:v>
                  </c:pt>
                </c:numCache>
              </c:numRef>
            </c:minus>
          </c:errBars>
          <c:xVal>
            <c:numRef>
              <c:f>Sheet1!$E$193:$U$193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194:$U$194</c:f>
              <c:numCache>
                <c:formatCode>General</c:formatCode>
                <c:ptCount val="17"/>
                <c:pt idx="0">
                  <c:v>254.78746624999997</c:v>
                </c:pt>
                <c:pt idx="1">
                  <c:v>157.6916415625</c:v>
                </c:pt>
                <c:pt idx="2">
                  <c:v>104.69441162500001</c:v>
                </c:pt>
                <c:pt idx="3">
                  <c:v>48.075105999999998</c:v>
                </c:pt>
                <c:pt idx="4">
                  <c:v>56.608543499999989</c:v>
                </c:pt>
                <c:pt idx="5">
                  <c:v>35.867940062500004</c:v>
                </c:pt>
                <c:pt idx="6">
                  <c:v>41.221710249999987</c:v>
                </c:pt>
                <c:pt idx="7">
                  <c:v>31.476255187500001</c:v>
                </c:pt>
                <c:pt idx="8">
                  <c:v>34.966198500000004</c:v>
                </c:pt>
                <c:pt idx="9">
                  <c:v>55.545532874999999</c:v>
                </c:pt>
                <c:pt idx="10">
                  <c:v>80.512993125000008</c:v>
                </c:pt>
                <c:pt idx="11">
                  <c:v>112.52809081249998</c:v>
                </c:pt>
                <c:pt idx="12">
                  <c:v>124.31535081250001</c:v>
                </c:pt>
                <c:pt idx="13">
                  <c:v>163.418918125</c:v>
                </c:pt>
                <c:pt idx="14">
                  <c:v>181.87672800000001</c:v>
                </c:pt>
                <c:pt idx="15">
                  <c:v>224.31914193749998</c:v>
                </c:pt>
                <c:pt idx="16">
                  <c:v>245.3026723124999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D$195</c:f>
              <c:strCache>
                <c:ptCount val="1"/>
                <c:pt idx="0">
                  <c:v>Osimertinib→Triplet</c:v>
                </c:pt>
              </c:strCache>
            </c:strRef>
          </c:tx>
          <c:spPr>
            <a:ln w="12700">
              <a:solidFill>
                <a:srgbClr val="C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E$143:$U$143</c:f>
                <c:numCache>
                  <c:formatCode>General</c:formatCode>
                  <c:ptCount val="17"/>
                  <c:pt idx="0">
                    <c:v>16.783348847635445</c:v>
                  </c:pt>
                  <c:pt idx="1">
                    <c:v>13.273536269954219</c:v>
                  </c:pt>
                  <c:pt idx="2">
                    <c:v>9.7346543374865888</c:v>
                  </c:pt>
                  <c:pt idx="3">
                    <c:v>5.9427898914260116</c:v>
                  </c:pt>
                  <c:pt idx="4">
                    <c:v>7.6421663640726871</c:v>
                  </c:pt>
                  <c:pt idx="5">
                    <c:v>17.076416743683417</c:v>
                  </c:pt>
                  <c:pt idx="6">
                    <c:v>17.120425236554009</c:v>
                  </c:pt>
                  <c:pt idx="7">
                    <c:v>15.845006787430171</c:v>
                  </c:pt>
                  <c:pt idx="8">
                    <c:v>23.186928842063985</c:v>
                  </c:pt>
                  <c:pt idx="9">
                    <c:v>27.645013080142476</c:v>
                  </c:pt>
                  <c:pt idx="10">
                    <c:v>42.585840788864012</c:v>
                  </c:pt>
                  <c:pt idx="11">
                    <c:v>55.924584114562265</c:v>
                  </c:pt>
                  <c:pt idx="12">
                    <c:v>76.75938631420513</c:v>
                  </c:pt>
                  <c:pt idx="13">
                    <c:v>80.32021171893399</c:v>
                  </c:pt>
                  <c:pt idx="14">
                    <c:v>69.694493504580834</c:v>
                  </c:pt>
                  <c:pt idx="15">
                    <c:v>81.850377552567068</c:v>
                  </c:pt>
                  <c:pt idx="16">
                    <c:v>93.9199852234867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E$193:$U$193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195:$U$195</c:f>
              <c:numCache>
                <c:formatCode>General</c:formatCode>
                <c:ptCount val="17"/>
                <c:pt idx="0">
                  <c:v>265.64156212500001</c:v>
                </c:pt>
                <c:pt idx="1">
                  <c:v>141.87077912499998</c:v>
                </c:pt>
                <c:pt idx="2">
                  <c:v>90.448344312500012</c:v>
                </c:pt>
                <c:pt idx="3">
                  <c:v>50.756968687499992</c:v>
                </c:pt>
                <c:pt idx="4">
                  <c:v>57.183056124999993</c:v>
                </c:pt>
                <c:pt idx="5">
                  <c:v>66.825287562499994</c:v>
                </c:pt>
                <c:pt idx="6">
                  <c:v>63.449229750000001</c:v>
                </c:pt>
                <c:pt idx="7">
                  <c:v>62.0905220625</c:v>
                </c:pt>
                <c:pt idx="8">
                  <c:v>79.907446000000007</c:v>
                </c:pt>
                <c:pt idx="9">
                  <c:v>94.354003062499999</c:v>
                </c:pt>
                <c:pt idx="10">
                  <c:v>120.869794125</c:v>
                </c:pt>
                <c:pt idx="11">
                  <c:v>160.285678875</c:v>
                </c:pt>
                <c:pt idx="12">
                  <c:v>201.36992218750001</c:v>
                </c:pt>
                <c:pt idx="13">
                  <c:v>237.85611468750002</c:v>
                </c:pt>
                <c:pt idx="14">
                  <c:v>226.30629143749999</c:v>
                </c:pt>
                <c:pt idx="15">
                  <c:v>261.52372087500004</c:v>
                </c:pt>
                <c:pt idx="16">
                  <c:v>296.241734499999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1971616"/>
        <c:axId val="-31969984"/>
      </c:scatterChart>
      <c:valAx>
        <c:axId val="-31971616"/>
        <c:scaling>
          <c:orientation val="minMax"/>
          <c:max val="5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ja-JP"/>
          </a:p>
        </c:txPr>
        <c:crossAx val="-31969984"/>
        <c:crosses val="autoZero"/>
        <c:crossBetween val="midCat"/>
        <c:majorUnit val="7"/>
      </c:valAx>
      <c:valAx>
        <c:axId val="-3196998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ja-JP"/>
          </a:p>
        </c:txPr>
        <c:crossAx val="-319716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0907839741944383"/>
          <c:y val="6.6278383957534645E-2"/>
          <c:w val="0.62097985281328894"/>
          <c:h val="0.22894252953319341"/>
        </c:manualLayout>
      </c:layout>
      <c:overlay val="0"/>
      <c:txPr>
        <a:bodyPr/>
        <a:lstStyle/>
        <a:p>
          <a:pPr>
            <a:defRPr sz="600" b="1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1787302761642358E-2"/>
          <c:y val="4.8889868983944242E-2"/>
          <c:w val="0.8975485996360153"/>
          <c:h val="0.8407953471374174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D$199</c:f>
              <c:strCache>
                <c:ptCount val="1"/>
                <c:pt idx="0">
                  <c:v>Osimertinib→Osimertinib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heet1!$E$202:$U$202</c:f>
                <c:numCache>
                  <c:formatCode>General</c:formatCode>
                  <c:ptCount val="17"/>
                  <c:pt idx="0">
                    <c:v>0.2750000000000003</c:v>
                  </c:pt>
                  <c:pt idx="1">
                    <c:v>0.28431203515386649</c:v>
                  </c:pt>
                  <c:pt idx="2">
                    <c:v>0.43660622991432402</c:v>
                  </c:pt>
                  <c:pt idx="3">
                    <c:v>0.32755406678389232</c:v>
                  </c:pt>
                  <c:pt idx="4">
                    <c:v>0.32500000000000018</c:v>
                  </c:pt>
                  <c:pt idx="5">
                    <c:v>0.20615528128088331</c:v>
                  </c:pt>
                  <c:pt idx="6">
                    <c:v>0.29545163168726418</c:v>
                  </c:pt>
                  <c:pt idx="7">
                    <c:v>0.59511903571190428</c:v>
                  </c:pt>
                  <c:pt idx="8">
                    <c:v>0.43851073723076267</c:v>
                  </c:pt>
                  <c:pt idx="9">
                    <c:v>0.40285439884239382</c:v>
                  </c:pt>
                  <c:pt idx="10">
                    <c:v>0.33911649915626335</c:v>
                  </c:pt>
                  <c:pt idx="11">
                    <c:v>0.46726152562920636</c:v>
                  </c:pt>
                  <c:pt idx="12">
                    <c:v>0.44814432199162491</c:v>
                  </c:pt>
                  <c:pt idx="13">
                    <c:v>0.50228643886398738</c:v>
                  </c:pt>
                  <c:pt idx="14">
                    <c:v>0.54772255750516585</c:v>
                  </c:pt>
                  <c:pt idx="15">
                    <c:v>0.53599595769619979</c:v>
                  </c:pt>
                  <c:pt idx="16">
                    <c:v>0.73936910042729487</c:v>
                  </c:pt>
                </c:numCache>
              </c:numRef>
            </c:minus>
          </c:errBars>
          <c:xVal>
            <c:numRef>
              <c:f>Sheet1!$E$198:$U$198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199:$U$199</c:f>
              <c:numCache>
                <c:formatCode>General</c:formatCode>
                <c:ptCount val="17"/>
                <c:pt idx="0">
                  <c:v>20.175000000000001</c:v>
                </c:pt>
                <c:pt idx="1">
                  <c:v>19.850000000000001</c:v>
                </c:pt>
                <c:pt idx="2">
                  <c:v>20.824999999999999</c:v>
                </c:pt>
                <c:pt idx="3">
                  <c:v>20.275000000000002</c:v>
                </c:pt>
                <c:pt idx="4">
                  <c:v>20.274999999999999</c:v>
                </c:pt>
                <c:pt idx="5">
                  <c:v>19.95</c:v>
                </c:pt>
                <c:pt idx="6">
                  <c:v>20.125</c:v>
                </c:pt>
                <c:pt idx="7">
                  <c:v>21.25</c:v>
                </c:pt>
                <c:pt idx="8">
                  <c:v>20.524999999999999</c:v>
                </c:pt>
                <c:pt idx="9">
                  <c:v>20.675000000000001</c:v>
                </c:pt>
                <c:pt idx="10">
                  <c:v>20.7</c:v>
                </c:pt>
                <c:pt idx="11">
                  <c:v>21.5</c:v>
                </c:pt>
                <c:pt idx="12">
                  <c:v>21.15</c:v>
                </c:pt>
                <c:pt idx="13">
                  <c:v>20.524999999999999</c:v>
                </c:pt>
                <c:pt idx="14">
                  <c:v>20.400000000000002</c:v>
                </c:pt>
                <c:pt idx="15">
                  <c:v>21.125</c:v>
                </c:pt>
                <c:pt idx="16">
                  <c:v>21.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D$200</c:f>
              <c:strCache>
                <c:ptCount val="1"/>
                <c:pt idx="0">
                  <c:v>Osimertinib→Triplet</c:v>
                </c:pt>
              </c:strCache>
            </c:strRef>
          </c:tx>
          <c:spPr>
            <a:ln w="12700">
              <a:solidFill>
                <a:srgbClr val="C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E$203:$U$203</c:f>
                <c:numCache>
                  <c:formatCode>General</c:formatCode>
                  <c:ptCount val="17"/>
                  <c:pt idx="0">
                    <c:v>0.31983068437325801</c:v>
                  </c:pt>
                  <c:pt idx="1">
                    <c:v>0.18257418583505569</c:v>
                  </c:pt>
                  <c:pt idx="2">
                    <c:v>0.3329164059239697</c:v>
                  </c:pt>
                  <c:pt idx="3">
                    <c:v>0.52757305971148072</c:v>
                  </c:pt>
                  <c:pt idx="4">
                    <c:v>0.51881274720911308</c:v>
                  </c:pt>
                  <c:pt idx="5">
                    <c:v>0.49833054625753526</c:v>
                  </c:pt>
                  <c:pt idx="6">
                    <c:v>0.32659863237109071</c:v>
                  </c:pt>
                  <c:pt idx="7">
                    <c:v>0.28686524130097496</c:v>
                  </c:pt>
                  <c:pt idx="8">
                    <c:v>0.44417526570788068</c:v>
                  </c:pt>
                  <c:pt idx="9">
                    <c:v>0.54829280498653254</c:v>
                  </c:pt>
                  <c:pt idx="10">
                    <c:v>0.43851073723076178</c:v>
                  </c:pt>
                  <c:pt idx="11">
                    <c:v>0.48304589153964794</c:v>
                  </c:pt>
                  <c:pt idx="12">
                    <c:v>0.61846584384264913</c:v>
                  </c:pt>
                  <c:pt idx="13">
                    <c:v>0.3300883720056394</c:v>
                  </c:pt>
                  <c:pt idx="14">
                    <c:v>0.3559026084010441</c:v>
                  </c:pt>
                  <c:pt idx="15">
                    <c:v>0.37499999999999972</c:v>
                  </c:pt>
                  <c:pt idx="16">
                    <c:v>0.490535421758714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E$198:$U$198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200:$U$200</c:f>
              <c:numCache>
                <c:formatCode>General</c:formatCode>
                <c:ptCount val="17"/>
                <c:pt idx="0">
                  <c:v>20.625</c:v>
                </c:pt>
                <c:pt idx="1">
                  <c:v>19.966666666666665</c:v>
                </c:pt>
                <c:pt idx="2">
                  <c:v>20.433333333333334</c:v>
                </c:pt>
                <c:pt idx="3">
                  <c:v>19.833333333333332</c:v>
                </c:pt>
                <c:pt idx="4">
                  <c:v>19.833333333333332</c:v>
                </c:pt>
                <c:pt idx="5">
                  <c:v>20.633333333333336</c:v>
                </c:pt>
                <c:pt idx="6">
                  <c:v>20.233333333333334</c:v>
                </c:pt>
                <c:pt idx="7">
                  <c:v>20.966666666666665</c:v>
                </c:pt>
                <c:pt idx="8">
                  <c:v>20.7</c:v>
                </c:pt>
                <c:pt idx="9">
                  <c:v>21.266666666666666</c:v>
                </c:pt>
                <c:pt idx="10">
                  <c:v>21.900000000000002</c:v>
                </c:pt>
                <c:pt idx="11">
                  <c:v>22.766666666666669</c:v>
                </c:pt>
                <c:pt idx="12">
                  <c:v>22.2</c:v>
                </c:pt>
                <c:pt idx="13">
                  <c:v>21.966666666666669</c:v>
                </c:pt>
                <c:pt idx="14">
                  <c:v>22.3</c:v>
                </c:pt>
                <c:pt idx="15">
                  <c:v>23.033333333333335</c:v>
                </c:pt>
                <c:pt idx="16">
                  <c:v>22.63333333333333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31973792"/>
        <c:axId val="-98921024"/>
      </c:scatterChart>
      <c:valAx>
        <c:axId val="-31973792"/>
        <c:scaling>
          <c:orientation val="minMax"/>
          <c:max val="5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ja-JP"/>
          </a:p>
        </c:txPr>
        <c:crossAx val="-98921024"/>
        <c:crosses val="autoZero"/>
        <c:crossBetween val="midCat"/>
        <c:majorUnit val="7"/>
      </c:valAx>
      <c:valAx>
        <c:axId val="-98921024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ja-JP"/>
          </a:p>
        </c:txPr>
        <c:crossAx val="-319737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0935135559650461"/>
          <c:y val="0.39979684082624545"/>
          <c:w val="0.64003520681610093"/>
          <c:h val="0.26567002094953179"/>
        </c:manualLayout>
      </c:layout>
      <c:overlay val="0"/>
      <c:txPr>
        <a:bodyPr/>
        <a:lstStyle/>
        <a:p>
          <a:pPr>
            <a:defRPr sz="600" b="1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214432" y="888171"/>
            <a:ext cx="2430225" cy="612851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428863" y="1620150"/>
            <a:ext cx="2001362" cy="73065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633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267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4900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53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167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980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1435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306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072839" y="114496"/>
            <a:ext cx="643295" cy="243949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42954" y="114496"/>
            <a:ext cx="1882233" cy="243949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25848" y="1837229"/>
            <a:ext cx="2430225" cy="567847"/>
          </a:xfrm>
        </p:spPr>
        <p:txBody>
          <a:bodyPr anchor="t"/>
          <a:lstStyle>
            <a:lvl1pPr algn="l">
              <a:defRPr sz="14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25848" y="1211804"/>
            <a:ext cx="2430225" cy="625425"/>
          </a:xfrm>
        </p:spPr>
        <p:txBody>
          <a:bodyPr anchor="b"/>
          <a:lstStyle>
            <a:lvl1pPr marL="0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1pPr>
            <a:lvl2pPr marL="163358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2pPr>
            <a:lvl3pPr marL="326715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3pPr>
            <a:lvl4pPr marL="490073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4pPr>
            <a:lvl5pPr marL="653430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5pPr>
            <a:lvl6pPr marL="816788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6pPr>
            <a:lvl7pPr marL="980145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7pPr>
            <a:lvl8pPr marL="1143503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8pPr>
            <a:lvl9pPr marL="1306860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42954" y="667121"/>
            <a:ext cx="1262764" cy="1886866"/>
          </a:xfrm>
        </p:spPr>
        <p:txBody>
          <a:bodyPr/>
          <a:lstStyle>
            <a:lvl1pPr>
              <a:defRPr sz="1000"/>
            </a:lvl1pPr>
            <a:lvl2pPr>
              <a:defRPr sz="9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53370" y="667121"/>
            <a:ext cx="1262764" cy="1886866"/>
          </a:xfrm>
        </p:spPr>
        <p:txBody>
          <a:bodyPr/>
          <a:lstStyle>
            <a:lvl1pPr>
              <a:defRPr sz="1000"/>
            </a:lvl1pPr>
            <a:lvl2pPr>
              <a:defRPr sz="9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42955" y="639986"/>
            <a:ext cx="1263260" cy="266716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63358" indent="0">
              <a:buNone/>
              <a:defRPr sz="700" b="1"/>
            </a:lvl2pPr>
            <a:lvl3pPr marL="326715" indent="0">
              <a:buNone/>
              <a:defRPr sz="600" b="1"/>
            </a:lvl3pPr>
            <a:lvl4pPr marL="490073" indent="0">
              <a:buNone/>
              <a:defRPr sz="600" b="1"/>
            </a:lvl4pPr>
            <a:lvl5pPr marL="653430" indent="0">
              <a:buNone/>
              <a:defRPr sz="600" b="1"/>
            </a:lvl5pPr>
            <a:lvl6pPr marL="816788" indent="0">
              <a:buNone/>
              <a:defRPr sz="600" b="1"/>
            </a:lvl6pPr>
            <a:lvl7pPr marL="980145" indent="0">
              <a:buNone/>
              <a:defRPr sz="600" b="1"/>
            </a:lvl7pPr>
            <a:lvl8pPr marL="1143503" indent="0">
              <a:buNone/>
              <a:defRPr sz="600" b="1"/>
            </a:lvl8pPr>
            <a:lvl9pPr marL="1306860" indent="0">
              <a:buNone/>
              <a:defRPr sz="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2955" y="906701"/>
            <a:ext cx="1263260" cy="1647285"/>
          </a:xfrm>
        </p:spPr>
        <p:txBody>
          <a:bodyPr/>
          <a:lstStyle>
            <a:lvl1pPr>
              <a:defRPr sz="900"/>
            </a:lvl1pPr>
            <a:lvl2pPr>
              <a:defRPr sz="700"/>
            </a:lvl2pPr>
            <a:lvl3pPr>
              <a:defRPr sz="6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1452377" y="639986"/>
            <a:ext cx="1263757" cy="266716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63358" indent="0">
              <a:buNone/>
              <a:defRPr sz="700" b="1"/>
            </a:lvl2pPr>
            <a:lvl3pPr marL="326715" indent="0">
              <a:buNone/>
              <a:defRPr sz="600" b="1"/>
            </a:lvl3pPr>
            <a:lvl4pPr marL="490073" indent="0">
              <a:buNone/>
              <a:defRPr sz="600" b="1"/>
            </a:lvl4pPr>
            <a:lvl5pPr marL="653430" indent="0">
              <a:buNone/>
              <a:defRPr sz="600" b="1"/>
            </a:lvl5pPr>
            <a:lvl6pPr marL="816788" indent="0">
              <a:buNone/>
              <a:defRPr sz="600" b="1"/>
            </a:lvl6pPr>
            <a:lvl7pPr marL="980145" indent="0">
              <a:buNone/>
              <a:defRPr sz="600" b="1"/>
            </a:lvl7pPr>
            <a:lvl8pPr marL="1143503" indent="0">
              <a:buNone/>
              <a:defRPr sz="600" b="1"/>
            </a:lvl8pPr>
            <a:lvl9pPr marL="1306860" indent="0">
              <a:buNone/>
              <a:defRPr sz="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1452377" y="906701"/>
            <a:ext cx="1263757" cy="1647285"/>
          </a:xfrm>
        </p:spPr>
        <p:txBody>
          <a:bodyPr/>
          <a:lstStyle>
            <a:lvl1pPr>
              <a:defRPr sz="900"/>
            </a:lvl1pPr>
            <a:lvl2pPr>
              <a:defRPr sz="700"/>
            </a:lvl2pPr>
            <a:lvl3pPr>
              <a:defRPr sz="6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2955" y="113834"/>
            <a:ext cx="940620" cy="484457"/>
          </a:xfrm>
        </p:spPr>
        <p:txBody>
          <a:bodyPr anchor="b"/>
          <a:lstStyle>
            <a:lvl1pPr algn="l">
              <a:defRPr sz="7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117824" y="113834"/>
            <a:ext cx="1598310" cy="2440152"/>
          </a:xfrm>
        </p:spPr>
        <p:txBody>
          <a:bodyPr/>
          <a:lstStyle>
            <a:lvl1pPr>
              <a:defRPr sz="1100"/>
            </a:lvl1pPr>
            <a:lvl2pPr>
              <a:defRPr sz="1000"/>
            </a:lvl2pPr>
            <a:lvl3pPr>
              <a:defRPr sz="9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42955" y="598291"/>
            <a:ext cx="940620" cy="1955696"/>
          </a:xfrm>
        </p:spPr>
        <p:txBody>
          <a:bodyPr/>
          <a:lstStyle>
            <a:lvl1pPr marL="0" indent="0">
              <a:buNone/>
              <a:defRPr sz="500"/>
            </a:lvl1pPr>
            <a:lvl2pPr marL="163358" indent="0">
              <a:buNone/>
              <a:defRPr sz="400"/>
            </a:lvl2pPr>
            <a:lvl3pPr marL="326715" indent="0">
              <a:buNone/>
              <a:defRPr sz="400"/>
            </a:lvl3pPr>
            <a:lvl4pPr marL="490073" indent="0">
              <a:buNone/>
              <a:defRPr sz="300"/>
            </a:lvl4pPr>
            <a:lvl5pPr marL="653430" indent="0">
              <a:buNone/>
              <a:defRPr sz="300"/>
            </a:lvl5pPr>
            <a:lvl6pPr marL="816788" indent="0">
              <a:buNone/>
              <a:defRPr sz="300"/>
            </a:lvl6pPr>
            <a:lvl7pPr marL="980145" indent="0">
              <a:buNone/>
              <a:defRPr sz="300"/>
            </a:lvl7pPr>
            <a:lvl8pPr marL="1143503" indent="0">
              <a:buNone/>
              <a:defRPr sz="300"/>
            </a:lvl8pPr>
            <a:lvl9pPr marL="1306860" indent="0">
              <a:buNone/>
              <a:defRPr sz="3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60401" y="2001362"/>
            <a:ext cx="1715453" cy="236272"/>
          </a:xfrm>
        </p:spPr>
        <p:txBody>
          <a:bodyPr anchor="b"/>
          <a:lstStyle>
            <a:lvl1pPr algn="l">
              <a:defRPr sz="7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560401" y="255465"/>
            <a:ext cx="1715453" cy="1715453"/>
          </a:xfrm>
        </p:spPr>
        <p:txBody>
          <a:bodyPr/>
          <a:lstStyle>
            <a:lvl1pPr marL="0" indent="0">
              <a:buNone/>
              <a:defRPr sz="1100"/>
            </a:lvl1pPr>
            <a:lvl2pPr marL="163358" indent="0">
              <a:buNone/>
              <a:defRPr sz="1000"/>
            </a:lvl2pPr>
            <a:lvl3pPr marL="326715" indent="0">
              <a:buNone/>
              <a:defRPr sz="900"/>
            </a:lvl3pPr>
            <a:lvl4pPr marL="490073" indent="0">
              <a:buNone/>
              <a:defRPr sz="700"/>
            </a:lvl4pPr>
            <a:lvl5pPr marL="653430" indent="0">
              <a:buNone/>
              <a:defRPr sz="700"/>
            </a:lvl5pPr>
            <a:lvl6pPr marL="816788" indent="0">
              <a:buNone/>
              <a:defRPr sz="700"/>
            </a:lvl6pPr>
            <a:lvl7pPr marL="980145" indent="0">
              <a:buNone/>
              <a:defRPr sz="700"/>
            </a:lvl7pPr>
            <a:lvl8pPr marL="1143503" indent="0">
              <a:buNone/>
              <a:defRPr sz="700"/>
            </a:lvl8pPr>
            <a:lvl9pPr marL="1306860" indent="0">
              <a:buNone/>
              <a:defRPr sz="7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60401" y="2237633"/>
            <a:ext cx="1715453" cy="335546"/>
          </a:xfrm>
        </p:spPr>
        <p:txBody>
          <a:bodyPr/>
          <a:lstStyle>
            <a:lvl1pPr marL="0" indent="0">
              <a:buNone/>
              <a:defRPr sz="500"/>
            </a:lvl1pPr>
            <a:lvl2pPr marL="163358" indent="0">
              <a:buNone/>
              <a:defRPr sz="400"/>
            </a:lvl2pPr>
            <a:lvl3pPr marL="326715" indent="0">
              <a:buNone/>
              <a:defRPr sz="400"/>
            </a:lvl3pPr>
            <a:lvl4pPr marL="490073" indent="0">
              <a:buNone/>
              <a:defRPr sz="300"/>
            </a:lvl4pPr>
            <a:lvl5pPr marL="653430" indent="0">
              <a:buNone/>
              <a:defRPr sz="300"/>
            </a:lvl5pPr>
            <a:lvl6pPr marL="816788" indent="0">
              <a:buNone/>
              <a:defRPr sz="300"/>
            </a:lvl6pPr>
            <a:lvl7pPr marL="980145" indent="0">
              <a:buNone/>
              <a:defRPr sz="300"/>
            </a:lvl7pPr>
            <a:lvl8pPr marL="1143503" indent="0">
              <a:buNone/>
              <a:defRPr sz="300"/>
            </a:lvl8pPr>
            <a:lvl9pPr marL="1306860" indent="0">
              <a:buNone/>
              <a:defRPr sz="3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142955" y="114496"/>
            <a:ext cx="2573179" cy="476515"/>
          </a:xfrm>
          <a:prstGeom prst="rect">
            <a:avLst/>
          </a:prstGeom>
        </p:spPr>
        <p:txBody>
          <a:bodyPr vert="horz" lIns="32672" tIns="16336" rIns="32672" bIns="16336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42955" y="667121"/>
            <a:ext cx="2573179" cy="1886866"/>
          </a:xfrm>
          <a:prstGeom prst="rect">
            <a:avLst/>
          </a:prstGeom>
        </p:spPr>
        <p:txBody>
          <a:bodyPr vert="horz" lIns="32672" tIns="16336" rIns="32672" bIns="16336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142954" y="2649951"/>
            <a:ext cx="667121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l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976855" y="2649951"/>
            <a:ext cx="905378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ct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2049013" y="2649951"/>
            <a:ext cx="667121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26715" rtl="0" eaLnBrk="1" latinLnBrk="0" hangingPunct="1">
        <a:spcBef>
          <a:spcPct val="0"/>
        </a:spcBef>
        <a:buNone/>
        <a:defRPr kumimoji="1" sz="1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2518" indent="-122518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65456" indent="-102098" algn="l" defTabSz="326715" rtl="0" eaLnBrk="1" latinLnBrk="0" hangingPunct="1">
        <a:spcBef>
          <a:spcPct val="20000"/>
        </a:spcBef>
        <a:buFont typeface="Arial" pitchFamily="34" charset="0"/>
        <a:buChar char="–"/>
        <a:defRPr kumimoji="1" sz="1000" kern="1200">
          <a:solidFill>
            <a:schemeClr val="tx1"/>
          </a:solidFill>
          <a:latin typeface="+mn-lt"/>
          <a:ea typeface="+mn-ea"/>
          <a:cs typeface="+mn-cs"/>
        </a:defRPr>
      </a:lvl2pPr>
      <a:lvl3pPr marL="408394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571751" indent="-81679" algn="l" defTabSz="326715" rtl="0" eaLnBrk="1" latinLnBrk="0" hangingPunct="1">
        <a:spcBef>
          <a:spcPct val="20000"/>
        </a:spcBef>
        <a:buFont typeface="Arial" pitchFamily="34" charset="0"/>
        <a:buChar char="–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4pPr>
      <a:lvl5pPr marL="735109" indent="-81679" algn="l" defTabSz="326715" rtl="0" eaLnBrk="1" latinLnBrk="0" hangingPunct="1">
        <a:spcBef>
          <a:spcPct val="20000"/>
        </a:spcBef>
        <a:buFont typeface="Arial" pitchFamily="34" charset="0"/>
        <a:buChar char="»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5pPr>
      <a:lvl6pPr marL="898467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6pPr>
      <a:lvl7pPr marL="1061824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7pPr>
      <a:lvl8pPr marL="1225182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8pPr>
      <a:lvl9pPr marL="1388539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1pPr>
      <a:lvl2pPr marL="163358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2pPr>
      <a:lvl3pPr marL="326715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3pPr>
      <a:lvl4pPr marL="490073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4pPr>
      <a:lvl5pPr marL="65343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5pPr>
      <a:lvl6pPr marL="816788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6pPr>
      <a:lvl7pPr marL="980145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7pPr>
      <a:lvl8pPr marL="1143503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8pPr>
      <a:lvl9pPr marL="130686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テキスト ボックス 87"/>
          <p:cNvSpPr txBox="1"/>
          <p:nvPr/>
        </p:nvSpPr>
        <p:spPr>
          <a:xfrm>
            <a:off x="61392" y="377535"/>
            <a:ext cx="514233" cy="794057"/>
          </a:xfrm>
          <a:prstGeom prst="rect">
            <a:avLst/>
          </a:prstGeom>
          <a:noFill/>
        </p:spPr>
        <p:txBody>
          <a:bodyPr vert="vert270" wrap="square" lIns="92070" tIns="46035" rIns="92070" bIns="46035" rtlCol="0">
            <a:spAutoFit/>
          </a:bodyPr>
          <a:lstStyle/>
          <a:p>
            <a:pPr algn="ctr"/>
            <a:r>
              <a:rPr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Tumor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olume (mm</a:t>
            </a:r>
            <a:r>
              <a:rPr lang="en-US" altLang="ja-JP" sz="800" b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r>
              <a:rPr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8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 algn="ctr"/>
            <a:endParaRPr lang="ja-JP" altLang="en-US" sz="8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2062376" y="1313639"/>
            <a:ext cx="503632" cy="216080"/>
          </a:xfrm>
          <a:prstGeom prst="rect">
            <a:avLst/>
          </a:prstGeom>
          <a:noFill/>
        </p:spPr>
        <p:txBody>
          <a:bodyPr wrap="square" lIns="92070" tIns="46035" rIns="92070" bIns="46035" rtlCol="0">
            <a:spAutoFit/>
          </a:bodyPr>
          <a:lstStyle/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8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720512" y="1400887"/>
            <a:ext cx="1038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0" y="133400"/>
            <a:ext cx="543572" cy="339816"/>
          </a:xfrm>
          <a:prstGeom prst="rect">
            <a:avLst/>
          </a:prstGeom>
          <a:noFill/>
        </p:spPr>
        <p:txBody>
          <a:bodyPr wrap="square" lIns="184131" tIns="92065" rIns="184131" bIns="92065" rtlCol="0">
            <a:spAutoFit/>
          </a:bodyPr>
          <a:lstStyle/>
          <a:p>
            <a:r>
              <a:rPr kumimoji="1" lang="en-US" altLang="ja-JP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3330" y="1429544"/>
            <a:ext cx="543572" cy="339816"/>
          </a:xfrm>
          <a:prstGeom prst="rect">
            <a:avLst/>
          </a:prstGeom>
          <a:noFill/>
        </p:spPr>
        <p:txBody>
          <a:bodyPr wrap="square" lIns="184131" tIns="92065" rIns="184131" bIns="92065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テキスト ボックス 18"/>
          <p:cNvSpPr txBox="1">
            <a:spLocks noChangeArrowheads="1"/>
          </p:cNvSpPr>
          <p:nvPr/>
        </p:nvSpPr>
        <p:spPr bwMode="auto">
          <a:xfrm rot="16200000">
            <a:off x="-120146" y="1915776"/>
            <a:ext cx="883793" cy="199362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sz="700" b="1" dirty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Body </a:t>
            </a: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weight (g) </a:t>
            </a:r>
            <a:endParaRPr lang="ja-JP" altLang="en-US" sz="700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085236" y="2567012"/>
            <a:ext cx="503632" cy="216080"/>
          </a:xfrm>
          <a:prstGeom prst="rect">
            <a:avLst/>
          </a:prstGeom>
          <a:noFill/>
        </p:spPr>
        <p:txBody>
          <a:bodyPr wrap="square" lIns="92070" tIns="46035" rIns="92070" bIns="46035" rtlCol="0">
            <a:spAutoFit/>
          </a:bodyPr>
          <a:lstStyle/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8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テキスト ボックス 2"/>
          <p:cNvSpPr txBox="1"/>
          <p:nvPr/>
        </p:nvSpPr>
        <p:spPr>
          <a:xfrm>
            <a:off x="-66793" y="-25515"/>
            <a:ext cx="10881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64484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328969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93454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57937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822421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986906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151390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315873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upp</a:t>
            </a:r>
            <a:r>
              <a:rPr kumimoji="1"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Figure7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3201310"/>
              </p:ext>
            </p:extLst>
          </p:nvPr>
        </p:nvGraphicFramePr>
        <p:xfrm>
          <a:off x="456516" y="220706"/>
          <a:ext cx="2088232" cy="11529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3" name="左右矢印 22"/>
          <p:cNvSpPr/>
          <p:nvPr/>
        </p:nvSpPr>
        <p:spPr>
          <a:xfrm>
            <a:off x="747564" y="1365156"/>
            <a:ext cx="360040" cy="54047"/>
          </a:xfrm>
          <a:prstGeom prst="leftRightArrow">
            <a:avLst/>
          </a:prstGeom>
          <a:solidFill>
            <a:schemeClr val="tx1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" name="左右矢印 24"/>
          <p:cNvSpPr/>
          <p:nvPr/>
        </p:nvSpPr>
        <p:spPr>
          <a:xfrm>
            <a:off x="1141512" y="1365156"/>
            <a:ext cx="360040" cy="54047"/>
          </a:xfrm>
          <a:prstGeom prst="leftRightArrow">
            <a:avLst/>
          </a:prstGeom>
          <a:solidFill>
            <a:schemeClr val="tx1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26" name="グラフ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8805414"/>
              </p:ext>
            </p:extLst>
          </p:nvPr>
        </p:nvGraphicFramePr>
        <p:xfrm>
          <a:off x="501977" y="1617222"/>
          <a:ext cx="2007687" cy="1028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7" name="テキスト ボックス 26"/>
          <p:cNvSpPr txBox="1"/>
          <p:nvPr/>
        </p:nvSpPr>
        <p:spPr>
          <a:xfrm>
            <a:off x="709464" y="2666551"/>
            <a:ext cx="1038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" name="左右矢印 27"/>
          <p:cNvSpPr/>
          <p:nvPr/>
        </p:nvSpPr>
        <p:spPr>
          <a:xfrm>
            <a:off x="736516" y="2630820"/>
            <a:ext cx="360040" cy="54047"/>
          </a:xfrm>
          <a:prstGeom prst="leftRightArrow">
            <a:avLst/>
          </a:prstGeom>
          <a:solidFill>
            <a:schemeClr val="tx1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" name="左右矢印 28"/>
          <p:cNvSpPr/>
          <p:nvPr/>
        </p:nvSpPr>
        <p:spPr>
          <a:xfrm>
            <a:off x="1130464" y="2630820"/>
            <a:ext cx="360040" cy="54047"/>
          </a:xfrm>
          <a:prstGeom prst="leftRightArrow">
            <a:avLst/>
          </a:prstGeom>
          <a:solidFill>
            <a:schemeClr val="tx1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04521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</TotalTime>
  <Words>24</Words>
  <Application>Microsoft Office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Helvetica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ichiro</dc:creator>
  <cp:lastModifiedBy>kadoaki</cp:lastModifiedBy>
  <cp:revision>28</cp:revision>
  <dcterms:created xsi:type="dcterms:W3CDTF">2016-08-27T13:38:19Z</dcterms:created>
  <dcterms:modified xsi:type="dcterms:W3CDTF">2017-03-26T03:00:57Z</dcterms:modified>
</cp:coreProperties>
</file>